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58701C-52C5-43F8-838E-E60AF329B2D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412A07-D25D-4A30-8FD7-39786E21BDB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C5BFB6-0167-46DB-91E9-4E12657BD30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A34CD7-FD4A-40C9-9230-86CCC438F0A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F71F2C-5BF1-4AD7-A066-DE805B372B1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9F3B61-E017-407B-A322-97573AF3BE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E6AFBB-30E8-419B-8391-7233523D649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CBD884-EE8C-4661-8F4F-716585B11E1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5F8EEA-F283-47DE-844A-4ECAAB2409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05A45-E890-4CED-871C-90F6607236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48D958-4699-4779-8AE1-BDAA0B7211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7A62A48-9B9F-4049-BB5D-E303FD1AFC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93047B7-8826-47A8-8825-472BDB0405C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flipV="1">
            <a:off x="1447920" y="3580920"/>
            <a:ext cx="0" cy="1600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905120" y="457200"/>
            <a:ext cx="0" cy="2514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1905120" y="762120"/>
            <a:ext cx="5943600" cy="18288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4" name=""/>
          <p:cNvSpPr/>
          <p:nvPr/>
        </p:nvSpPr>
        <p:spPr>
          <a:xfrm>
            <a:off x="1447920" y="1295280"/>
            <a:ext cx="93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6 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1447920" y="1447920"/>
            <a:ext cx="93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5 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447920" y="1600200"/>
            <a:ext cx="93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4 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447920" y="1752480"/>
            <a:ext cx="93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3 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447920" y="1905120"/>
            <a:ext cx="938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   </a:t>
            </a: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2   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981080" y="2666880"/>
            <a:ext cx="152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re     Mid     Po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429000" y="457200"/>
            <a:ext cx="0" cy="2514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800600" y="457200"/>
            <a:ext cx="0" cy="2514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6324480" y="457200"/>
            <a:ext cx="0" cy="2514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2133720" y="487440"/>
            <a:ext cx="1090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atient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3429000" y="2666880"/>
            <a:ext cx="152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re      Mid   Po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800600" y="2666880"/>
            <a:ext cx="152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re       Mid    Po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6324480" y="2666880"/>
            <a:ext cx="152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re      Mid    Po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838080" y="1523880"/>
            <a:ext cx="914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harg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633840" y="487440"/>
            <a:ext cx="1090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atient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5029200" y="487440"/>
            <a:ext cx="1090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atient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6529320" y="487440"/>
            <a:ext cx="1090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atient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04920" y="196920"/>
            <a:ext cx="3873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2" name="" descr=""/>
          <p:cNvPicPr/>
          <p:nvPr/>
        </p:nvPicPr>
        <p:blipFill>
          <a:blip r:embed="rId2"/>
          <a:srcRect l="0" t="1538" r="2219" b="0"/>
          <a:stretch/>
        </p:blipFill>
        <p:spPr>
          <a:xfrm>
            <a:off x="1447920" y="3886200"/>
            <a:ext cx="6705360" cy="9730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3" name=""/>
          <p:cNvSpPr/>
          <p:nvPr/>
        </p:nvSpPr>
        <p:spPr>
          <a:xfrm>
            <a:off x="609480" y="3946680"/>
            <a:ext cx="9907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po C-III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609480" y="4114800"/>
            <a:ext cx="99072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po C-III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609480" y="4343400"/>
            <a:ext cx="1067040" cy="267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Apo C-III</a:t>
            </a:r>
            <a:r>
              <a:rPr b="1" lang="en-US" sz="1000" spc="-1" strike="noStrike" baseline="-25000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295280" y="4114800"/>
            <a:ext cx="152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295280" y="4267080"/>
            <a:ext cx="152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295280" y="4495680"/>
            <a:ext cx="152640" cy="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4114800" y="3581280"/>
            <a:ext cx="0" cy="1600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5486400" y="3581280"/>
            <a:ext cx="0" cy="1600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6858000" y="3581280"/>
            <a:ext cx="0" cy="1600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971800" y="3611520"/>
            <a:ext cx="106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atient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371600" y="3611520"/>
            <a:ext cx="1523880" cy="30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C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1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  NC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2  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NC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+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819520" y="3581280"/>
            <a:ext cx="0" cy="1600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819520" y="4876920"/>
            <a:ext cx="152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re    Mid    Po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114800" y="4876920"/>
            <a:ext cx="152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re     Mid   Po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5562720" y="4876920"/>
            <a:ext cx="1523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re     Mid   Po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6858000" y="4876920"/>
            <a:ext cx="144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re    Mid   Pos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7010280" y="3611520"/>
            <a:ext cx="106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atient 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5638680" y="3611520"/>
            <a:ext cx="106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atient 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267080" y="3611520"/>
            <a:ext cx="106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Patient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306360" y="335268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609480" y="304920"/>
            <a:ext cx="7696440" cy="28191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7848720" y="457200"/>
            <a:ext cx="0" cy="2514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609480" y="3429000"/>
            <a:ext cx="7696440" cy="190512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8153280" y="3581280"/>
            <a:ext cx="0" cy="16002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11-28T14:28:11Z</dcterms:created>
  <dc:creator>Site License</dc:creator>
  <dc:description/>
  <dc:language>en-US</dc:language>
  <cp:lastModifiedBy>Site License</cp:lastModifiedBy>
  <dcterms:modified xsi:type="dcterms:W3CDTF">2006-11-28T14:28:43Z</dcterms:modified>
  <cp:revision>1</cp:revision>
  <dc:subject/>
  <dc:title>PowerPoint Presentation</dc:title>
</cp:coreProperties>
</file>